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73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>
      <p:cViewPr varScale="1">
        <p:scale>
          <a:sx n="128" d="100"/>
          <a:sy n="128" d="100"/>
        </p:scale>
        <p:origin x="170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49054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39197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21971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79966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58648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12473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55247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34724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56083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28900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82621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5008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14840B96-9F14-5C43-8868-8B5E0808B709}"/>
              </a:ext>
            </a:extLst>
          </p:cNvPr>
          <p:cNvSpPr txBox="1"/>
          <p:nvPr/>
        </p:nvSpPr>
        <p:spPr>
          <a:xfrm>
            <a:off x="187421" y="5566742"/>
            <a:ext cx="8769158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Mov</a:t>
            </a:r>
            <a:r>
              <a:rPr lang="en-US" altLang="ja-JP" sz="1100" b="1">
                <a:latin typeface="Arial" panose="020B0604020202020204" pitchFamily="34" charset="0"/>
                <a:cs typeface="Arial" panose="020B0604020202020204" pitchFamily="34" charset="0"/>
              </a:rPr>
              <a:t>. 2</a:t>
            </a:r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Video of a marmoset jumping and tracking when it is moving quickly. </a:t>
            </a:r>
          </a:p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a) Raw video frame. (b) 3D coordinate of marmosets detected using Lidar. White point: centroid of marmosets, white box: virtual space of the cage. (c) Location of marmosets on video frame detected using Yolo, box: detected marmosets. (d) 3D coordinate of marmosets calculated using video tracking, colored point: coordinate of marmoset. (e, f) Individual information added to C and D using face identification; green: marmoset A, red: marmoset B, yellow: marmoset C.</a:t>
            </a:r>
            <a:endParaRPr lang="ja-JP" altLang="ja-JP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media2">
            <a:hlinkClick r:id="" action="ppaction://media"/>
            <a:extLst>
              <a:ext uri="{FF2B5EF4-FFF2-40B4-BE49-F238E27FC236}">
                <a16:creationId xmlns:a16="http://schemas.microsoft.com/office/drawing/2014/main" id="{2AF5BB6B-C783-74D4-77CF-BAF41044CC1C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392866" y="0"/>
            <a:ext cx="6999398" cy="52495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200321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8916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20</Words>
  <Application>Microsoft Macintosh PowerPoint</Application>
  <PresentationFormat>画面に合わせる (4:3)</PresentationFormat>
  <Paragraphs>2</Paragraphs>
  <Slides>1</Slides>
  <Notes>0</Notes>
  <HiddenSlides>0</HiddenSlides>
  <MMClips>1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晃海 圦本</dc:creator>
  <cp:lastModifiedBy>晃海 圦本</cp:lastModifiedBy>
  <cp:revision>6</cp:revision>
  <dcterms:created xsi:type="dcterms:W3CDTF">2023-07-18T01:28:01Z</dcterms:created>
  <dcterms:modified xsi:type="dcterms:W3CDTF">2024-01-18T11:42:37Z</dcterms:modified>
</cp:coreProperties>
</file>